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8" d="100"/>
          <a:sy n="78" d="100"/>
        </p:scale>
        <p:origin x="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18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764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149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73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10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390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3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260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3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0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776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05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455" y="780282"/>
            <a:ext cx="7938795" cy="3533452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95444" y="160544"/>
            <a:ext cx="346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4642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16377" y="545068"/>
            <a:ext cx="842554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4. Endoscopic findings of esophageal varices before and after EIS</a:t>
            </a:r>
            <a:endParaRPr lang="ja-JP" altLang="ja-JP" sz="14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Before EIS (F2 esophageal varices), (B) After EIS (White cord). </a:t>
            </a:r>
            <a:endParaRPr lang="ja-JP" altLang="ja-JP" sz="14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IS has been performed until the varices were eradicated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0215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画面に合わせる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重福 隆太</dc:creator>
  <cp:lastModifiedBy>重福 隆太</cp:lastModifiedBy>
  <cp:revision>3</cp:revision>
  <dcterms:created xsi:type="dcterms:W3CDTF">2021-10-17T09:25:07Z</dcterms:created>
  <dcterms:modified xsi:type="dcterms:W3CDTF">2021-12-23T16:43:12Z</dcterms:modified>
</cp:coreProperties>
</file>